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media/image3.jpeg" ContentType="image/jpeg"/>
  <Override PartName="/ppt/media/image4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724DE9-5277-42B3-9EC8-3A3DB7259FD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D97C86-3610-4050-860B-B2ECCED7C3D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AF3F04-DA24-4044-890A-669EA703619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85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5608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14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85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5608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086869-ECDA-44AA-8151-76DFFE8A0DF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8E7CCB-FC50-414C-9C52-8BD143CEC70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9DE75D-577F-420A-BAFF-26191F1F02C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684DDD-70E6-4B1B-A172-B4CCD0C6A97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328CA9-3284-48C0-8A68-B882E9F792B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4440" y="812520"/>
            <a:ext cx="58291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049CFF-0895-42BC-A365-AE5928491CE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59089E-C510-405E-B389-8BCA2483A4A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C30EE2-F10B-4CC9-A85A-6016460CA8E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0EF47B-68B3-489D-8D57-AAE9FB7FEF9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14080" y="8331120"/>
            <a:ext cx="142884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31120"/>
            <a:ext cx="217152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5080" y="8331120"/>
            <a:ext cx="142848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71EABC8-9972-4F26-8899-F49C728E22E9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76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42" name="" descr=""/>
          <p:cNvPicPr/>
          <p:nvPr/>
        </p:nvPicPr>
        <p:blipFill>
          <a:blip r:embed="rId1"/>
          <a:stretch/>
        </p:blipFill>
        <p:spPr>
          <a:xfrm>
            <a:off x="4653000" y="6227640"/>
            <a:ext cx="2074680" cy="2766960"/>
          </a:xfrm>
          <a:prstGeom prst="rect">
            <a:avLst/>
          </a:prstGeom>
          <a:ln w="0">
            <a:noFill/>
          </a:ln>
        </p:spPr>
      </p:pic>
      <p:pic>
        <p:nvPicPr>
          <p:cNvPr id="43" name="" descr=""/>
          <p:cNvPicPr/>
          <p:nvPr/>
        </p:nvPicPr>
        <p:blipFill>
          <a:blip r:embed="rId2"/>
          <a:stretch/>
        </p:blipFill>
        <p:spPr>
          <a:xfrm>
            <a:off x="130320" y="6227640"/>
            <a:ext cx="2074680" cy="2766960"/>
          </a:xfrm>
          <a:prstGeom prst="rect">
            <a:avLst/>
          </a:prstGeom>
          <a:ln w="0">
            <a:noFill/>
          </a:ln>
        </p:spPr>
      </p:pic>
      <p:pic>
        <p:nvPicPr>
          <p:cNvPr id="44" name="" descr=""/>
          <p:cNvPicPr/>
          <p:nvPr/>
        </p:nvPicPr>
        <p:blipFill>
          <a:blip r:embed="rId3"/>
          <a:stretch/>
        </p:blipFill>
        <p:spPr>
          <a:xfrm>
            <a:off x="4653000" y="149400"/>
            <a:ext cx="2074680" cy="2766960"/>
          </a:xfrm>
          <a:prstGeom prst="rect">
            <a:avLst/>
          </a:prstGeom>
          <a:ln w="0">
            <a:noFill/>
          </a:ln>
        </p:spPr>
      </p:pic>
      <p:pic>
        <p:nvPicPr>
          <p:cNvPr id="45" name="" descr=""/>
          <p:cNvPicPr/>
          <p:nvPr/>
        </p:nvPicPr>
        <p:blipFill>
          <a:blip r:embed="rId4"/>
          <a:stretch/>
        </p:blipFill>
        <p:spPr>
          <a:xfrm>
            <a:off x="130320" y="149400"/>
            <a:ext cx="2074680" cy="2766960"/>
          </a:xfrm>
          <a:prstGeom prst="rect">
            <a:avLst/>
          </a:prstGeom>
          <a:ln w="0">
            <a:noFill/>
          </a:ln>
        </p:spPr>
      </p:pic>
      <p:sp>
        <p:nvSpPr>
          <p:cNvPr id="46" name="PlaceHolder 1"/>
          <p:cNvSpPr>
            <a:spLocks noGrp="1"/>
          </p:cNvSpPr>
          <p:nvPr>
            <p:ph type="title"/>
          </p:nvPr>
        </p:nvSpPr>
        <p:spPr>
          <a:xfrm>
            <a:off x="2347920" y="228600"/>
            <a:ext cx="2160720" cy="533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) Objects: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4 different objects were used to produce complex sensory stimulation (CSS).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7" name=""/>
          <p:cNvSpPr/>
          <p:nvPr/>
        </p:nvSpPr>
        <p:spPr>
          <a:xfrm>
            <a:off x="130320" y="2987640"/>
            <a:ext cx="2074680" cy="13716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Food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: fruitloops of different flavors/scents were cached inside a hollow compartment made of a PVC-tube segment. The object had a putative positive value.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8" name=""/>
          <p:cNvSpPr/>
          <p:nvPr/>
        </p:nvSpPr>
        <p:spPr>
          <a:xfrm>
            <a:off x="4638600" y="2987640"/>
            <a:ext cx="2089080" cy="11890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Brush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: a common shoe brush was sectioned in two and reassembled so as to generate a concave surface with a hair-like texture of putative neutral value.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9" name=""/>
          <p:cNvSpPr/>
          <p:nvPr/>
        </p:nvSpPr>
        <p:spPr>
          <a:xfrm>
            <a:off x="130320" y="4952880"/>
            <a:ext cx="2074680" cy="11890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Ball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: a golf ball was attached to a metal spring to create a moving target of smooth texture and globular surface, with a putative neutral value.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0" name=""/>
          <p:cNvSpPr/>
          <p:nvPr/>
        </p:nvSpPr>
        <p:spPr>
          <a:xfrm>
            <a:off x="4624560" y="5334120"/>
            <a:ext cx="2089080" cy="82404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Urchin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: metal poster pins were glued to a wooden axis to create a spiky object of putative negative value.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11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3-03-27T01:46:11Z</dcterms:created>
  <dc:creator>Sidarta Ribeiro</dc:creator>
  <dc:description/>
  <dc:language>en-US</dc:language>
  <cp:lastModifiedBy>Liana Holmberg</cp:lastModifiedBy>
  <dcterms:modified xsi:type="dcterms:W3CDTF">2003-12-05T00:12:11Z</dcterms:modified>
  <cp:revision>85</cp:revision>
  <dc:subject/>
  <dc:title>Supplementary Material</dc:title>
</cp:coreProperties>
</file>